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9" r:id="rId2"/>
  </p:sldIdLst>
  <p:sldSz cx="34361438" cy="45720000"/>
  <p:notesSz cx="6858000" cy="9144000"/>
  <p:defaultTextStyle>
    <a:defPPr>
      <a:defRPr lang="zh-CN"/>
    </a:defPPr>
    <a:lvl1pPr marL="0" algn="l" defTabSz="4576023" rtl="0" eaLnBrk="1" latinLnBrk="0" hangingPunct="1">
      <a:defRPr sz="9008" kern="1200">
        <a:solidFill>
          <a:schemeClr val="tx1"/>
        </a:solidFill>
        <a:latin typeface="+mn-lt"/>
        <a:ea typeface="+mn-ea"/>
        <a:cs typeface="+mn-cs"/>
      </a:defRPr>
    </a:lvl1pPr>
    <a:lvl2pPr marL="2288012" algn="l" defTabSz="4576023" rtl="0" eaLnBrk="1" latinLnBrk="0" hangingPunct="1">
      <a:defRPr sz="9008" kern="1200">
        <a:solidFill>
          <a:schemeClr val="tx1"/>
        </a:solidFill>
        <a:latin typeface="+mn-lt"/>
        <a:ea typeface="+mn-ea"/>
        <a:cs typeface="+mn-cs"/>
      </a:defRPr>
    </a:lvl2pPr>
    <a:lvl3pPr marL="4576023" algn="l" defTabSz="4576023" rtl="0" eaLnBrk="1" latinLnBrk="0" hangingPunct="1">
      <a:defRPr sz="9008" kern="1200">
        <a:solidFill>
          <a:schemeClr val="tx1"/>
        </a:solidFill>
        <a:latin typeface="+mn-lt"/>
        <a:ea typeface="+mn-ea"/>
        <a:cs typeface="+mn-cs"/>
      </a:defRPr>
    </a:lvl3pPr>
    <a:lvl4pPr marL="6864035" algn="l" defTabSz="4576023" rtl="0" eaLnBrk="1" latinLnBrk="0" hangingPunct="1">
      <a:defRPr sz="9008" kern="1200">
        <a:solidFill>
          <a:schemeClr val="tx1"/>
        </a:solidFill>
        <a:latin typeface="+mn-lt"/>
        <a:ea typeface="+mn-ea"/>
        <a:cs typeface="+mn-cs"/>
      </a:defRPr>
    </a:lvl4pPr>
    <a:lvl5pPr marL="9152047" algn="l" defTabSz="4576023" rtl="0" eaLnBrk="1" latinLnBrk="0" hangingPunct="1">
      <a:defRPr sz="9008" kern="1200">
        <a:solidFill>
          <a:schemeClr val="tx1"/>
        </a:solidFill>
        <a:latin typeface="+mn-lt"/>
        <a:ea typeface="+mn-ea"/>
        <a:cs typeface="+mn-cs"/>
      </a:defRPr>
    </a:lvl5pPr>
    <a:lvl6pPr marL="11440058" algn="l" defTabSz="4576023" rtl="0" eaLnBrk="1" latinLnBrk="0" hangingPunct="1">
      <a:defRPr sz="9008" kern="1200">
        <a:solidFill>
          <a:schemeClr val="tx1"/>
        </a:solidFill>
        <a:latin typeface="+mn-lt"/>
        <a:ea typeface="+mn-ea"/>
        <a:cs typeface="+mn-cs"/>
      </a:defRPr>
    </a:lvl6pPr>
    <a:lvl7pPr marL="13728070" algn="l" defTabSz="4576023" rtl="0" eaLnBrk="1" latinLnBrk="0" hangingPunct="1">
      <a:defRPr sz="9008" kern="1200">
        <a:solidFill>
          <a:schemeClr val="tx1"/>
        </a:solidFill>
        <a:latin typeface="+mn-lt"/>
        <a:ea typeface="+mn-ea"/>
        <a:cs typeface="+mn-cs"/>
      </a:defRPr>
    </a:lvl7pPr>
    <a:lvl8pPr marL="16016082" algn="l" defTabSz="4576023" rtl="0" eaLnBrk="1" latinLnBrk="0" hangingPunct="1">
      <a:defRPr sz="9008" kern="1200">
        <a:solidFill>
          <a:schemeClr val="tx1"/>
        </a:solidFill>
        <a:latin typeface="+mn-lt"/>
        <a:ea typeface="+mn-ea"/>
        <a:cs typeface="+mn-cs"/>
      </a:defRPr>
    </a:lvl8pPr>
    <a:lvl9pPr marL="18304093" algn="l" defTabSz="4576023" rtl="0" eaLnBrk="1" latinLnBrk="0" hangingPunct="1">
      <a:defRPr sz="900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6213" userDrawn="1">
          <p15:clr>
            <a:srgbClr val="A4A3A4"/>
          </p15:clr>
        </p15:guide>
        <p15:guide id="2" pos="1184" userDrawn="1">
          <p15:clr>
            <a:srgbClr val="A4A3A4"/>
          </p15:clr>
        </p15:guide>
        <p15:guide id="3" orient="horz" pos="25682">
          <p15:clr>
            <a:srgbClr val="A4A3A4"/>
          </p15:clr>
        </p15:guide>
        <p15:guide id="4" pos="183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638" autoAdjust="0"/>
    <p:restoredTop sz="96424" autoAdjust="0"/>
  </p:normalViewPr>
  <p:slideViewPr>
    <p:cSldViewPr snapToGrid="0">
      <p:cViewPr varScale="1">
        <p:scale>
          <a:sx n="16" d="100"/>
          <a:sy n="16" d="100"/>
        </p:scale>
        <p:origin x="-3402" y="-228"/>
      </p:cViewPr>
      <p:guideLst>
        <p:guide orient="horz" pos="6213"/>
        <p:guide orient="horz" pos="25682"/>
        <p:guide pos="1184"/>
        <p:guide pos="1830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" d="100"/>
        <a:sy n="2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9596B2-6F1B-4B49-83F7-05F3DEA32197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68538" y="1143000"/>
            <a:ext cx="23209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B6414B-7BF7-4EED-B3BF-2D2525E1B5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72233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77108" y="7482420"/>
            <a:ext cx="29207222" cy="15917333"/>
          </a:xfrm>
        </p:spPr>
        <p:txBody>
          <a:bodyPr anchor="b"/>
          <a:lstStyle>
            <a:lvl1pPr algn="ctr">
              <a:defRPr sz="22547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295180" y="24013587"/>
            <a:ext cx="25771079" cy="11038413"/>
          </a:xfrm>
        </p:spPr>
        <p:txBody>
          <a:bodyPr/>
          <a:lstStyle>
            <a:lvl1pPr marL="0" indent="0" algn="ctr">
              <a:buNone/>
              <a:defRPr sz="9019"/>
            </a:lvl1pPr>
            <a:lvl2pPr marL="1718066" indent="0" algn="ctr">
              <a:buNone/>
              <a:defRPr sz="7516"/>
            </a:lvl2pPr>
            <a:lvl3pPr marL="3436132" indent="0" algn="ctr">
              <a:buNone/>
              <a:defRPr sz="6764"/>
            </a:lvl3pPr>
            <a:lvl4pPr marL="5154198" indent="0" algn="ctr">
              <a:buNone/>
              <a:defRPr sz="6012"/>
            </a:lvl4pPr>
            <a:lvl5pPr marL="6872265" indent="0" algn="ctr">
              <a:buNone/>
              <a:defRPr sz="6012"/>
            </a:lvl5pPr>
            <a:lvl6pPr marL="8590331" indent="0" algn="ctr">
              <a:buNone/>
              <a:defRPr sz="6012"/>
            </a:lvl6pPr>
            <a:lvl7pPr marL="10308397" indent="0" algn="ctr">
              <a:buNone/>
              <a:defRPr sz="6012"/>
            </a:lvl7pPr>
            <a:lvl8pPr marL="12026463" indent="0" algn="ctr">
              <a:buNone/>
              <a:defRPr sz="6012"/>
            </a:lvl8pPr>
            <a:lvl9pPr marL="13744529" indent="0" algn="ctr">
              <a:buNone/>
              <a:defRPr sz="6012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4698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1684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4589906" y="2434167"/>
            <a:ext cx="7409185" cy="3874558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62351" y="2434167"/>
            <a:ext cx="21798037" cy="3874558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9834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8238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44454" y="11398263"/>
            <a:ext cx="29636740" cy="19018247"/>
          </a:xfrm>
        </p:spPr>
        <p:txBody>
          <a:bodyPr anchor="b"/>
          <a:lstStyle>
            <a:lvl1pPr>
              <a:defRPr sz="22547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44454" y="30596430"/>
            <a:ext cx="29636740" cy="10001247"/>
          </a:xfrm>
        </p:spPr>
        <p:txBody>
          <a:bodyPr/>
          <a:lstStyle>
            <a:lvl1pPr marL="0" indent="0">
              <a:buNone/>
              <a:defRPr sz="9019">
                <a:solidFill>
                  <a:schemeClr val="tx1"/>
                </a:solidFill>
              </a:defRPr>
            </a:lvl1pPr>
            <a:lvl2pPr marL="1718066" indent="0">
              <a:buNone/>
              <a:defRPr sz="7516">
                <a:solidFill>
                  <a:schemeClr val="tx1">
                    <a:tint val="75000"/>
                  </a:schemeClr>
                </a:solidFill>
              </a:defRPr>
            </a:lvl2pPr>
            <a:lvl3pPr marL="3436132" indent="0">
              <a:buNone/>
              <a:defRPr sz="6764">
                <a:solidFill>
                  <a:schemeClr val="tx1">
                    <a:tint val="75000"/>
                  </a:schemeClr>
                </a:solidFill>
              </a:defRPr>
            </a:lvl3pPr>
            <a:lvl4pPr marL="5154198" indent="0">
              <a:buNone/>
              <a:defRPr sz="6012">
                <a:solidFill>
                  <a:schemeClr val="tx1">
                    <a:tint val="75000"/>
                  </a:schemeClr>
                </a:solidFill>
              </a:defRPr>
            </a:lvl4pPr>
            <a:lvl5pPr marL="6872265" indent="0">
              <a:buNone/>
              <a:defRPr sz="6012">
                <a:solidFill>
                  <a:schemeClr val="tx1">
                    <a:tint val="75000"/>
                  </a:schemeClr>
                </a:solidFill>
              </a:defRPr>
            </a:lvl5pPr>
            <a:lvl6pPr marL="8590331" indent="0">
              <a:buNone/>
              <a:defRPr sz="6012">
                <a:solidFill>
                  <a:schemeClr val="tx1">
                    <a:tint val="75000"/>
                  </a:schemeClr>
                </a:solidFill>
              </a:defRPr>
            </a:lvl6pPr>
            <a:lvl7pPr marL="10308397" indent="0">
              <a:buNone/>
              <a:defRPr sz="6012">
                <a:solidFill>
                  <a:schemeClr val="tx1">
                    <a:tint val="75000"/>
                  </a:schemeClr>
                </a:solidFill>
              </a:defRPr>
            </a:lvl7pPr>
            <a:lvl8pPr marL="12026463" indent="0">
              <a:buNone/>
              <a:defRPr sz="6012">
                <a:solidFill>
                  <a:schemeClr val="tx1">
                    <a:tint val="75000"/>
                  </a:schemeClr>
                </a:solidFill>
              </a:defRPr>
            </a:lvl8pPr>
            <a:lvl9pPr marL="13744529" indent="0">
              <a:buNone/>
              <a:defRPr sz="60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2634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62349" y="12170833"/>
            <a:ext cx="14603611" cy="2900892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95478" y="12170833"/>
            <a:ext cx="14603611" cy="2900892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700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66825" y="2434177"/>
            <a:ext cx="29636740" cy="8837087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66828" y="11207753"/>
            <a:ext cx="14536497" cy="5492747"/>
          </a:xfrm>
        </p:spPr>
        <p:txBody>
          <a:bodyPr anchor="b"/>
          <a:lstStyle>
            <a:lvl1pPr marL="0" indent="0">
              <a:buNone/>
              <a:defRPr sz="9019" b="1"/>
            </a:lvl1pPr>
            <a:lvl2pPr marL="1718066" indent="0">
              <a:buNone/>
              <a:defRPr sz="7516" b="1"/>
            </a:lvl2pPr>
            <a:lvl3pPr marL="3436132" indent="0">
              <a:buNone/>
              <a:defRPr sz="6764" b="1"/>
            </a:lvl3pPr>
            <a:lvl4pPr marL="5154198" indent="0">
              <a:buNone/>
              <a:defRPr sz="6012" b="1"/>
            </a:lvl4pPr>
            <a:lvl5pPr marL="6872265" indent="0">
              <a:buNone/>
              <a:defRPr sz="6012" b="1"/>
            </a:lvl5pPr>
            <a:lvl6pPr marL="8590331" indent="0">
              <a:buNone/>
              <a:defRPr sz="6012" b="1"/>
            </a:lvl6pPr>
            <a:lvl7pPr marL="10308397" indent="0">
              <a:buNone/>
              <a:defRPr sz="6012" b="1"/>
            </a:lvl7pPr>
            <a:lvl8pPr marL="12026463" indent="0">
              <a:buNone/>
              <a:defRPr sz="6012" b="1"/>
            </a:lvl8pPr>
            <a:lvl9pPr marL="13744529" indent="0">
              <a:buNone/>
              <a:defRPr sz="6012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66828" y="16700500"/>
            <a:ext cx="14536497" cy="2456392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7395480" y="11207753"/>
            <a:ext cx="14608087" cy="5492747"/>
          </a:xfrm>
        </p:spPr>
        <p:txBody>
          <a:bodyPr anchor="b"/>
          <a:lstStyle>
            <a:lvl1pPr marL="0" indent="0">
              <a:buNone/>
              <a:defRPr sz="9019" b="1"/>
            </a:lvl1pPr>
            <a:lvl2pPr marL="1718066" indent="0">
              <a:buNone/>
              <a:defRPr sz="7516" b="1"/>
            </a:lvl2pPr>
            <a:lvl3pPr marL="3436132" indent="0">
              <a:buNone/>
              <a:defRPr sz="6764" b="1"/>
            </a:lvl3pPr>
            <a:lvl4pPr marL="5154198" indent="0">
              <a:buNone/>
              <a:defRPr sz="6012" b="1"/>
            </a:lvl4pPr>
            <a:lvl5pPr marL="6872265" indent="0">
              <a:buNone/>
              <a:defRPr sz="6012" b="1"/>
            </a:lvl5pPr>
            <a:lvl6pPr marL="8590331" indent="0">
              <a:buNone/>
              <a:defRPr sz="6012" b="1"/>
            </a:lvl6pPr>
            <a:lvl7pPr marL="10308397" indent="0">
              <a:buNone/>
              <a:defRPr sz="6012" b="1"/>
            </a:lvl7pPr>
            <a:lvl8pPr marL="12026463" indent="0">
              <a:buNone/>
              <a:defRPr sz="6012" b="1"/>
            </a:lvl8pPr>
            <a:lvl9pPr marL="13744529" indent="0">
              <a:buNone/>
              <a:defRPr sz="6012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7395480" y="16700500"/>
            <a:ext cx="14608087" cy="2456392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1098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3600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0080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66824" y="3048000"/>
            <a:ext cx="11082458" cy="10668000"/>
          </a:xfrm>
        </p:spPr>
        <p:txBody>
          <a:bodyPr anchor="b"/>
          <a:lstStyle>
            <a:lvl1pPr>
              <a:defRPr sz="1202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608087" y="6582844"/>
            <a:ext cx="17395478" cy="32490833"/>
          </a:xfrm>
        </p:spPr>
        <p:txBody>
          <a:bodyPr/>
          <a:lstStyle>
            <a:lvl1pPr>
              <a:defRPr sz="12025"/>
            </a:lvl1pPr>
            <a:lvl2pPr>
              <a:defRPr sz="10522"/>
            </a:lvl2pPr>
            <a:lvl3pPr>
              <a:defRPr sz="9019"/>
            </a:lvl3pPr>
            <a:lvl4pPr>
              <a:defRPr sz="7516"/>
            </a:lvl4pPr>
            <a:lvl5pPr>
              <a:defRPr sz="7516"/>
            </a:lvl5pPr>
            <a:lvl6pPr>
              <a:defRPr sz="7516"/>
            </a:lvl6pPr>
            <a:lvl7pPr>
              <a:defRPr sz="7516"/>
            </a:lvl7pPr>
            <a:lvl8pPr>
              <a:defRPr sz="7516"/>
            </a:lvl8pPr>
            <a:lvl9pPr>
              <a:defRPr sz="7516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66824" y="13716000"/>
            <a:ext cx="11082458" cy="25410587"/>
          </a:xfrm>
        </p:spPr>
        <p:txBody>
          <a:bodyPr/>
          <a:lstStyle>
            <a:lvl1pPr marL="0" indent="0">
              <a:buNone/>
              <a:defRPr sz="6012"/>
            </a:lvl1pPr>
            <a:lvl2pPr marL="1718066" indent="0">
              <a:buNone/>
              <a:defRPr sz="5261"/>
            </a:lvl2pPr>
            <a:lvl3pPr marL="3436132" indent="0">
              <a:buNone/>
              <a:defRPr sz="4509"/>
            </a:lvl3pPr>
            <a:lvl4pPr marL="5154198" indent="0">
              <a:buNone/>
              <a:defRPr sz="3758"/>
            </a:lvl4pPr>
            <a:lvl5pPr marL="6872265" indent="0">
              <a:buNone/>
              <a:defRPr sz="3758"/>
            </a:lvl5pPr>
            <a:lvl6pPr marL="8590331" indent="0">
              <a:buNone/>
              <a:defRPr sz="3758"/>
            </a:lvl6pPr>
            <a:lvl7pPr marL="10308397" indent="0">
              <a:buNone/>
              <a:defRPr sz="3758"/>
            </a:lvl7pPr>
            <a:lvl8pPr marL="12026463" indent="0">
              <a:buNone/>
              <a:defRPr sz="3758"/>
            </a:lvl8pPr>
            <a:lvl9pPr marL="13744529" indent="0">
              <a:buNone/>
              <a:defRPr sz="3758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1185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66824" y="3048000"/>
            <a:ext cx="11082458" cy="10668000"/>
          </a:xfrm>
        </p:spPr>
        <p:txBody>
          <a:bodyPr anchor="b"/>
          <a:lstStyle>
            <a:lvl1pPr>
              <a:defRPr sz="1202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4608087" y="6582844"/>
            <a:ext cx="17395478" cy="32490833"/>
          </a:xfrm>
        </p:spPr>
        <p:txBody>
          <a:bodyPr anchor="t"/>
          <a:lstStyle>
            <a:lvl1pPr marL="0" indent="0">
              <a:buNone/>
              <a:defRPr sz="12025"/>
            </a:lvl1pPr>
            <a:lvl2pPr marL="1718066" indent="0">
              <a:buNone/>
              <a:defRPr sz="10522"/>
            </a:lvl2pPr>
            <a:lvl3pPr marL="3436132" indent="0">
              <a:buNone/>
              <a:defRPr sz="9019"/>
            </a:lvl3pPr>
            <a:lvl4pPr marL="5154198" indent="0">
              <a:buNone/>
              <a:defRPr sz="7516"/>
            </a:lvl4pPr>
            <a:lvl5pPr marL="6872265" indent="0">
              <a:buNone/>
              <a:defRPr sz="7516"/>
            </a:lvl5pPr>
            <a:lvl6pPr marL="8590331" indent="0">
              <a:buNone/>
              <a:defRPr sz="7516"/>
            </a:lvl6pPr>
            <a:lvl7pPr marL="10308397" indent="0">
              <a:buNone/>
              <a:defRPr sz="7516"/>
            </a:lvl7pPr>
            <a:lvl8pPr marL="12026463" indent="0">
              <a:buNone/>
              <a:defRPr sz="7516"/>
            </a:lvl8pPr>
            <a:lvl9pPr marL="13744529" indent="0">
              <a:buNone/>
              <a:defRPr sz="7516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66824" y="13716000"/>
            <a:ext cx="11082458" cy="25410587"/>
          </a:xfrm>
        </p:spPr>
        <p:txBody>
          <a:bodyPr/>
          <a:lstStyle>
            <a:lvl1pPr marL="0" indent="0">
              <a:buNone/>
              <a:defRPr sz="6012"/>
            </a:lvl1pPr>
            <a:lvl2pPr marL="1718066" indent="0">
              <a:buNone/>
              <a:defRPr sz="5261"/>
            </a:lvl2pPr>
            <a:lvl3pPr marL="3436132" indent="0">
              <a:buNone/>
              <a:defRPr sz="4509"/>
            </a:lvl3pPr>
            <a:lvl4pPr marL="5154198" indent="0">
              <a:buNone/>
              <a:defRPr sz="3758"/>
            </a:lvl4pPr>
            <a:lvl5pPr marL="6872265" indent="0">
              <a:buNone/>
              <a:defRPr sz="3758"/>
            </a:lvl5pPr>
            <a:lvl6pPr marL="8590331" indent="0">
              <a:buNone/>
              <a:defRPr sz="3758"/>
            </a:lvl6pPr>
            <a:lvl7pPr marL="10308397" indent="0">
              <a:buNone/>
              <a:defRPr sz="3758"/>
            </a:lvl7pPr>
            <a:lvl8pPr marL="12026463" indent="0">
              <a:buNone/>
              <a:defRPr sz="3758"/>
            </a:lvl8pPr>
            <a:lvl9pPr marL="13744529" indent="0">
              <a:buNone/>
              <a:defRPr sz="3758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881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362349" y="2434177"/>
            <a:ext cx="29636740" cy="88370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62349" y="12170833"/>
            <a:ext cx="29636740" cy="290089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362349" y="42375677"/>
            <a:ext cx="7731324" cy="2434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5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09144-BC7E-4263-BF4F-A5AC8F734D23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382227" y="42375677"/>
            <a:ext cx="11596985" cy="2434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5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4267765" y="42375677"/>
            <a:ext cx="7731324" cy="2434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5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03498-43BF-435D-8BE0-F580938111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346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3436132" rtl="0" eaLnBrk="1" latinLnBrk="0" hangingPunct="1">
        <a:lnSpc>
          <a:spcPct val="90000"/>
        </a:lnSpc>
        <a:spcBef>
          <a:spcPct val="0"/>
        </a:spcBef>
        <a:buNone/>
        <a:defRPr sz="1653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59033" indent="-859033" algn="l" defTabSz="3436132" rtl="0" eaLnBrk="1" latinLnBrk="0" hangingPunct="1">
        <a:lnSpc>
          <a:spcPct val="90000"/>
        </a:lnSpc>
        <a:spcBef>
          <a:spcPts val="3758"/>
        </a:spcBef>
        <a:buFont typeface="Arial" panose="020B0604020202020204" pitchFamily="34" charset="0"/>
        <a:buChar char="•"/>
        <a:defRPr sz="10522" kern="1200">
          <a:solidFill>
            <a:schemeClr val="tx1"/>
          </a:solidFill>
          <a:latin typeface="+mn-lt"/>
          <a:ea typeface="+mn-ea"/>
          <a:cs typeface="+mn-cs"/>
        </a:defRPr>
      </a:lvl1pPr>
      <a:lvl2pPr marL="2577099" indent="-859033" algn="l" defTabSz="3436132" rtl="0" eaLnBrk="1" latinLnBrk="0" hangingPunct="1">
        <a:lnSpc>
          <a:spcPct val="90000"/>
        </a:lnSpc>
        <a:spcBef>
          <a:spcPts val="1879"/>
        </a:spcBef>
        <a:buFont typeface="Arial" panose="020B0604020202020204" pitchFamily="34" charset="0"/>
        <a:buChar char="•"/>
        <a:defRPr sz="9019" kern="1200">
          <a:solidFill>
            <a:schemeClr val="tx1"/>
          </a:solidFill>
          <a:latin typeface="+mn-lt"/>
          <a:ea typeface="+mn-ea"/>
          <a:cs typeface="+mn-cs"/>
        </a:defRPr>
      </a:lvl2pPr>
      <a:lvl3pPr marL="4295165" indent="-859033" algn="l" defTabSz="3436132" rtl="0" eaLnBrk="1" latinLnBrk="0" hangingPunct="1">
        <a:lnSpc>
          <a:spcPct val="90000"/>
        </a:lnSpc>
        <a:spcBef>
          <a:spcPts val="1879"/>
        </a:spcBef>
        <a:buFont typeface="Arial" panose="020B0604020202020204" pitchFamily="34" charset="0"/>
        <a:buChar char="•"/>
        <a:defRPr sz="7516" kern="1200">
          <a:solidFill>
            <a:schemeClr val="tx1"/>
          </a:solidFill>
          <a:latin typeface="+mn-lt"/>
          <a:ea typeface="+mn-ea"/>
          <a:cs typeface="+mn-cs"/>
        </a:defRPr>
      </a:lvl3pPr>
      <a:lvl4pPr marL="6013232" indent="-859033" algn="l" defTabSz="3436132" rtl="0" eaLnBrk="1" latinLnBrk="0" hangingPunct="1">
        <a:lnSpc>
          <a:spcPct val="90000"/>
        </a:lnSpc>
        <a:spcBef>
          <a:spcPts val="1879"/>
        </a:spcBef>
        <a:buFont typeface="Arial" panose="020B0604020202020204" pitchFamily="34" charset="0"/>
        <a:buChar char="•"/>
        <a:defRPr sz="6764" kern="1200">
          <a:solidFill>
            <a:schemeClr val="tx1"/>
          </a:solidFill>
          <a:latin typeface="+mn-lt"/>
          <a:ea typeface="+mn-ea"/>
          <a:cs typeface="+mn-cs"/>
        </a:defRPr>
      </a:lvl4pPr>
      <a:lvl5pPr marL="7731298" indent="-859033" algn="l" defTabSz="3436132" rtl="0" eaLnBrk="1" latinLnBrk="0" hangingPunct="1">
        <a:lnSpc>
          <a:spcPct val="90000"/>
        </a:lnSpc>
        <a:spcBef>
          <a:spcPts val="1879"/>
        </a:spcBef>
        <a:buFont typeface="Arial" panose="020B0604020202020204" pitchFamily="34" charset="0"/>
        <a:buChar char="•"/>
        <a:defRPr sz="6764" kern="1200">
          <a:solidFill>
            <a:schemeClr val="tx1"/>
          </a:solidFill>
          <a:latin typeface="+mn-lt"/>
          <a:ea typeface="+mn-ea"/>
          <a:cs typeface="+mn-cs"/>
        </a:defRPr>
      </a:lvl5pPr>
      <a:lvl6pPr marL="9449364" indent="-859033" algn="l" defTabSz="3436132" rtl="0" eaLnBrk="1" latinLnBrk="0" hangingPunct="1">
        <a:lnSpc>
          <a:spcPct val="90000"/>
        </a:lnSpc>
        <a:spcBef>
          <a:spcPts val="1879"/>
        </a:spcBef>
        <a:buFont typeface="Arial" panose="020B0604020202020204" pitchFamily="34" charset="0"/>
        <a:buChar char="•"/>
        <a:defRPr sz="6764" kern="1200">
          <a:solidFill>
            <a:schemeClr val="tx1"/>
          </a:solidFill>
          <a:latin typeface="+mn-lt"/>
          <a:ea typeface="+mn-ea"/>
          <a:cs typeface="+mn-cs"/>
        </a:defRPr>
      </a:lvl6pPr>
      <a:lvl7pPr marL="11167430" indent="-859033" algn="l" defTabSz="3436132" rtl="0" eaLnBrk="1" latinLnBrk="0" hangingPunct="1">
        <a:lnSpc>
          <a:spcPct val="90000"/>
        </a:lnSpc>
        <a:spcBef>
          <a:spcPts val="1879"/>
        </a:spcBef>
        <a:buFont typeface="Arial" panose="020B0604020202020204" pitchFamily="34" charset="0"/>
        <a:buChar char="•"/>
        <a:defRPr sz="6764" kern="1200">
          <a:solidFill>
            <a:schemeClr val="tx1"/>
          </a:solidFill>
          <a:latin typeface="+mn-lt"/>
          <a:ea typeface="+mn-ea"/>
          <a:cs typeface="+mn-cs"/>
        </a:defRPr>
      </a:lvl7pPr>
      <a:lvl8pPr marL="12885496" indent="-859033" algn="l" defTabSz="3436132" rtl="0" eaLnBrk="1" latinLnBrk="0" hangingPunct="1">
        <a:lnSpc>
          <a:spcPct val="90000"/>
        </a:lnSpc>
        <a:spcBef>
          <a:spcPts val="1879"/>
        </a:spcBef>
        <a:buFont typeface="Arial" panose="020B0604020202020204" pitchFamily="34" charset="0"/>
        <a:buChar char="•"/>
        <a:defRPr sz="6764" kern="1200">
          <a:solidFill>
            <a:schemeClr val="tx1"/>
          </a:solidFill>
          <a:latin typeface="+mn-lt"/>
          <a:ea typeface="+mn-ea"/>
          <a:cs typeface="+mn-cs"/>
        </a:defRPr>
      </a:lvl8pPr>
      <a:lvl9pPr marL="14603562" indent="-859033" algn="l" defTabSz="3436132" rtl="0" eaLnBrk="1" latinLnBrk="0" hangingPunct="1">
        <a:lnSpc>
          <a:spcPct val="90000"/>
        </a:lnSpc>
        <a:spcBef>
          <a:spcPts val="1879"/>
        </a:spcBef>
        <a:buFont typeface="Arial" panose="020B0604020202020204" pitchFamily="34" charset="0"/>
        <a:buChar char="•"/>
        <a:defRPr sz="676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36132" rtl="0" eaLnBrk="1" latinLnBrk="0" hangingPunct="1">
        <a:defRPr sz="6764" kern="1200">
          <a:solidFill>
            <a:schemeClr val="tx1"/>
          </a:solidFill>
          <a:latin typeface="+mn-lt"/>
          <a:ea typeface="+mn-ea"/>
          <a:cs typeface="+mn-cs"/>
        </a:defRPr>
      </a:lvl1pPr>
      <a:lvl2pPr marL="1718066" algn="l" defTabSz="3436132" rtl="0" eaLnBrk="1" latinLnBrk="0" hangingPunct="1">
        <a:defRPr sz="6764" kern="1200">
          <a:solidFill>
            <a:schemeClr val="tx1"/>
          </a:solidFill>
          <a:latin typeface="+mn-lt"/>
          <a:ea typeface="+mn-ea"/>
          <a:cs typeface="+mn-cs"/>
        </a:defRPr>
      </a:lvl2pPr>
      <a:lvl3pPr marL="3436132" algn="l" defTabSz="3436132" rtl="0" eaLnBrk="1" latinLnBrk="0" hangingPunct="1">
        <a:defRPr sz="6764" kern="1200">
          <a:solidFill>
            <a:schemeClr val="tx1"/>
          </a:solidFill>
          <a:latin typeface="+mn-lt"/>
          <a:ea typeface="+mn-ea"/>
          <a:cs typeface="+mn-cs"/>
        </a:defRPr>
      </a:lvl3pPr>
      <a:lvl4pPr marL="5154198" algn="l" defTabSz="3436132" rtl="0" eaLnBrk="1" latinLnBrk="0" hangingPunct="1">
        <a:defRPr sz="6764" kern="1200">
          <a:solidFill>
            <a:schemeClr val="tx1"/>
          </a:solidFill>
          <a:latin typeface="+mn-lt"/>
          <a:ea typeface="+mn-ea"/>
          <a:cs typeface="+mn-cs"/>
        </a:defRPr>
      </a:lvl4pPr>
      <a:lvl5pPr marL="6872265" algn="l" defTabSz="3436132" rtl="0" eaLnBrk="1" latinLnBrk="0" hangingPunct="1">
        <a:defRPr sz="6764" kern="1200">
          <a:solidFill>
            <a:schemeClr val="tx1"/>
          </a:solidFill>
          <a:latin typeface="+mn-lt"/>
          <a:ea typeface="+mn-ea"/>
          <a:cs typeface="+mn-cs"/>
        </a:defRPr>
      </a:lvl5pPr>
      <a:lvl6pPr marL="8590331" algn="l" defTabSz="3436132" rtl="0" eaLnBrk="1" latinLnBrk="0" hangingPunct="1">
        <a:defRPr sz="6764" kern="1200">
          <a:solidFill>
            <a:schemeClr val="tx1"/>
          </a:solidFill>
          <a:latin typeface="+mn-lt"/>
          <a:ea typeface="+mn-ea"/>
          <a:cs typeface="+mn-cs"/>
        </a:defRPr>
      </a:lvl6pPr>
      <a:lvl7pPr marL="10308397" algn="l" defTabSz="3436132" rtl="0" eaLnBrk="1" latinLnBrk="0" hangingPunct="1">
        <a:defRPr sz="6764" kern="1200">
          <a:solidFill>
            <a:schemeClr val="tx1"/>
          </a:solidFill>
          <a:latin typeface="+mn-lt"/>
          <a:ea typeface="+mn-ea"/>
          <a:cs typeface="+mn-cs"/>
        </a:defRPr>
      </a:lvl7pPr>
      <a:lvl8pPr marL="12026463" algn="l" defTabSz="3436132" rtl="0" eaLnBrk="1" latinLnBrk="0" hangingPunct="1">
        <a:defRPr sz="6764" kern="1200">
          <a:solidFill>
            <a:schemeClr val="tx1"/>
          </a:solidFill>
          <a:latin typeface="+mn-lt"/>
          <a:ea typeface="+mn-ea"/>
          <a:cs typeface="+mn-cs"/>
        </a:defRPr>
      </a:lvl8pPr>
      <a:lvl9pPr marL="13744529" algn="l" defTabSz="3436132" rtl="0" eaLnBrk="1" latinLnBrk="0" hangingPunct="1">
        <a:defRPr sz="676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7171" y="3444657"/>
            <a:ext cx="9336084" cy="61704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701492" y="1468357"/>
            <a:ext cx="769980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Soft tissue cancer, GSE30929, ID:204642_at, RFS,</a:t>
            </a:r>
          </a:p>
          <a:p>
            <a:pPr algn="ctr"/>
            <a:r>
              <a:rPr lang="en-US" altLang="zh-CN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HR=0.27, Cox </a:t>
            </a:r>
            <a:r>
              <a:rPr lang="en-US" altLang="zh-CN" sz="4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=0.000255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52414" y="3620620"/>
            <a:ext cx="10453826" cy="61704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2709840" y="1484229"/>
            <a:ext cx="778201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Blood cancer, GSE5122, ID:204642_at, OS,</a:t>
            </a:r>
          </a:p>
          <a:p>
            <a:pPr algn="ctr"/>
            <a:r>
              <a:rPr lang="en-US" altLang="zh-CN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HR=0.64, Cox </a:t>
            </a:r>
            <a:r>
              <a:rPr lang="en-US" altLang="zh-CN" sz="4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=0.000508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002750" y="3414571"/>
            <a:ext cx="10139663" cy="61704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3448671" y="1559637"/>
            <a:ext cx="844211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Brain </a:t>
            </a:r>
            <a:r>
              <a:rPr lang="en-US" altLang="zh-CN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cancer, </a:t>
            </a:r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GSE1456-GPL96</a:t>
            </a:r>
            <a:r>
              <a:rPr lang="en-US" altLang="zh-CN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, ID:204642_at, OS,</a:t>
            </a:r>
          </a:p>
          <a:p>
            <a:pPr algn="ctr"/>
            <a:r>
              <a:rPr lang="en-US" altLang="zh-CN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HR=0.68, Cox </a:t>
            </a:r>
            <a:r>
              <a:rPr lang="en-US" altLang="zh-CN" sz="4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=0.048802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81337" y="18688050"/>
            <a:ext cx="78781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00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7200" dirty="0">
                <a:latin typeface="Arial" pitchFamily="34" charset="0"/>
                <a:cs typeface="Arial" pitchFamily="34" charset="0"/>
              </a:rPr>
              <a:t>S</a:t>
            </a:r>
            <a:r>
              <a:rPr lang="en-US" altLang="zh-CN" sz="7200" dirty="0" smtClean="0">
                <a:latin typeface="Arial" pitchFamily="34" charset="0"/>
                <a:cs typeface="Arial" pitchFamily="34" charset="0"/>
              </a:rPr>
              <a:t>1</a:t>
            </a:r>
            <a:endParaRPr lang="zh-CN" altLang="en-US" sz="7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95881" y="1079064"/>
            <a:ext cx="146388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1245957" y="1080000"/>
            <a:ext cx="146388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1946688" y="1080000"/>
            <a:ext cx="146388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2451244" y="10008000"/>
            <a:ext cx="146388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组合 25"/>
          <p:cNvGrpSpPr/>
          <p:nvPr/>
        </p:nvGrpSpPr>
        <p:grpSpPr>
          <a:xfrm>
            <a:off x="3227557" y="10969778"/>
            <a:ext cx="6282000" cy="6453450"/>
            <a:chOff x="1751996" y="12919137"/>
            <a:chExt cx="6282000" cy="6453450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51996" y="12919137"/>
              <a:ext cx="6282000" cy="6282000"/>
            </a:xfrm>
            <a:prstGeom prst="rect">
              <a:avLst/>
            </a:prstGeom>
          </p:spPr>
        </p:pic>
        <p:sp>
          <p:nvSpPr>
            <p:cNvPr id="18" name="矩形 17"/>
            <p:cNvSpPr/>
            <p:nvPr/>
          </p:nvSpPr>
          <p:spPr>
            <a:xfrm>
              <a:off x="1751996" y="18545175"/>
              <a:ext cx="6282000" cy="8274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矩形 24"/>
            <p:cNvSpPr/>
            <p:nvPr/>
          </p:nvSpPr>
          <p:spPr>
            <a:xfrm>
              <a:off x="2889947" y="18602611"/>
              <a:ext cx="4376519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4000" dirty="0" smtClean="0">
                  <a:latin typeface="Arial" pitchFamily="34" charset="0"/>
                  <a:cs typeface="Arial" pitchFamily="34" charset="0"/>
                </a:rPr>
                <a:t>Gastric </a:t>
              </a:r>
              <a:r>
                <a:rPr lang="en-US" altLang="zh-CN" sz="4000" dirty="0">
                  <a:latin typeface="Arial" pitchFamily="34" charset="0"/>
                  <a:cs typeface="Arial" pitchFamily="34" charset="0"/>
                </a:rPr>
                <a:t>cancer </a:t>
              </a:r>
              <a:r>
                <a:rPr lang="en-US" altLang="zh-CN" sz="4000" dirty="0" smtClean="0">
                  <a:latin typeface="Arial" pitchFamily="34" charset="0"/>
                  <a:cs typeface="Arial" pitchFamily="34" charset="0"/>
                </a:rPr>
                <a:t>OS</a:t>
              </a:r>
              <a:endParaRPr lang="zh-CN" altLang="en-US" sz="4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1" name="组合 30"/>
          <p:cNvGrpSpPr/>
          <p:nvPr/>
        </p:nvGrpSpPr>
        <p:grpSpPr>
          <a:xfrm>
            <a:off x="13829795" y="11000071"/>
            <a:ext cx="6838950" cy="6474549"/>
            <a:chOff x="10772270" y="12065972"/>
            <a:chExt cx="6838950" cy="6474549"/>
          </a:xfrm>
        </p:grpSpPr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41894" y="12065972"/>
              <a:ext cx="6282000" cy="6282000"/>
            </a:xfrm>
            <a:prstGeom prst="rect">
              <a:avLst/>
            </a:prstGeom>
          </p:spPr>
        </p:pic>
        <p:sp>
          <p:nvSpPr>
            <p:cNvPr id="27" name="矩形 26"/>
            <p:cNvSpPr/>
            <p:nvPr/>
          </p:nvSpPr>
          <p:spPr>
            <a:xfrm>
              <a:off x="10772270" y="17713109"/>
              <a:ext cx="6282000" cy="8274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" name="矩形 28"/>
            <p:cNvSpPr/>
            <p:nvPr/>
          </p:nvSpPr>
          <p:spPr>
            <a:xfrm>
              <a:off x="11892173" y="17713109"/>
              <a:ext cx="5719047" cy="70788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4000" dirty="0">
                  <a:latin typeface="Arial" pitchFamily="34" charset="0"/>
                  <a:cs typeface="Arial" pitchFamily="34" charset="0"/>
                </a:rPr>
                <a:t>Gastric cancer </a:t>
              </a:r>
              <a:r>
                <a:rPr lang="en-US" altLang="zh-CN" sz="4000" dirty="0" smtClean="0">
                  <a:latin typeface="Arial" pitchFamily="34" charset="0"/>
                  <a:cs typeface="Arial" pitchFamily="34" charset="0"/>
                </a:rPr>
                <a:t>FP</a:t>
              </a:r>
              <a:endParaRPr lang="zh-CN" altLang="en-US" sz="4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2" name="组合 31"/>
          <p:cNvGrpSpPr/>
          <p:nvPr/>
        </p:nvGrpSpPr>
        <p:grpSpPr>
          <a:xfrm>
            <a:off x="24341011" y="11000071"/>
            <a:ext cx="6539932" cy="6282000"/>
            <a:chOff x="17696945" y="12052316"/>
            <a:chExt cx="6539932" cy="6282000"/>
          </a:xfrm>
        </p:grpSpPr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54877" y="12052316"/>
              <a:ext cx="6282000" cy="6282000"/>
            </a:xfrm>
            <a:prstGeom prst="rect">
              <a:avLst/>
            </a:prstGeom>
          </p:spPr>
        </p:pic>
        <p:sp>
          <p:nvSpPr>
            <p:cNvPr id="28" name="矩形 27"/>
            <p:cNvSpPr/>
            <p:nvPr/>
          </p:nvSpPr>
          <p:spPr>
            <a:xfrm>
              <a:off x="17696945" y="17423228"/>
              <a:ext cx="6282000" cy="8274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" name="矩形 29"/>
            <p:cNvSpPr/>
            <p:nvPr/>
          </p:nvSpPr>
          <p:spPr>
            <a:xfrm>
              <a:off x="19013415" y="17588920"/>
              <a:ext cx="4965530" cy="70788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4000" dirty="0">
                  <a:latin typeface="Arial" pitchFamily="34" charset="0"/>
                  <a:cs typeface="Arial" pitchFamily="34" charset="0"/>
                </a:rPr>
                <a:t>Gastric cancer </a:t>
              </a:r>
              <a:r>
                <a:rPr lang="en-US" altLang="zh-CN" sz="4000" dirty="0" smtClean="0">
                  <a:latin typeface="Arial" pitchFamily="34" charset="0"/>
                  <a:cs typeface="Arial" pitchFamily="34" charset="0"/>
                </a:rPr>
                <a:t>PPS</a:t>
              </a:r>
              <a:endParaRPr lang="zh-CN" altLang="en-US" sz="4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3" name="文本框 20"/>
          <p:cNvSpPr txBox="1"/>
          <p:nvPr/>
        </p:nvSpPr>
        <p:spPr>
          <a:xfrm>
            <a:off x="681337" y="10008000"/>
            <a:ext cx="146388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21"/>
          <p:cNvSpPr txBox="1"/>
          <p:nvPr/>
        </p:nvSpPr>
        <p:spPr>
          <a:xfrm>
            <a:off x="11483813" y="10008000"/>
            <a:ext cx="146388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6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6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79925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sz="6600" dirty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40</TotalTime>
  <Words>57</Words>
  <Application>Microsoft Office PowerPoint</Application>
  <PresentationFormat>自定义</PresentationFormat>
  <Paragraphs>1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 Yu-feng</dc:creator>
  <cp:lastModifiedBy>Windows User</cp:lastModifiedBy>
  <cp:revision>190</cp:revision>
  <dcterms:created xsi:type="dcterms:W3CDTF">2020-02-22T11:57:22Z</dcterms:created>
  <dcterms:modified xsi:type="dcterms:W3CDTF">2020-06-12T07:45:14Z</dcterms:modified>
</cp:coreProperties>
</file>